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8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2704" userDrawn="1">
          <p15:clr>
            <a:srgbClr val="A4A3A4"/>
          </p15:clr>
        </p15:guide>
        <p15:guide id="3" orient="horz" pos="1434" userDrawn="1">
          <p15:clr>
            <a:srgbClr val="A4A3A4"/>
          </p15:clr>
        </p15:guide>
        <p15:guide id="5" pos="884" userDrawn="1">
          <p15:clr>
            <a:srgbClr val="A4A3A4"/>
          </p15:clr>
        </p15:guide>
        <p15:guide id="6" pos="4513" userDrawn="1">
          <p15:clr>
            <a:srgbClr val="A4A3A4"/>
          </p15:clr>
        </p15:guide>
        <p15:guide id="7" pos="567">
          <p15:clr>
            <a:srgbClr val="A4A3A4"/>
          </p15:clr>
        </p15:guide>
        <p15:guide id="8" pos="21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71EE"/>
    <a:srgbClr val="EE6C15"/>
    <a:srgbClr val="619CFF"/>
    <a:srgbClr val="F8766D"/>
    <a:srgbClr val="00BFC4"/>
    <a:srgbClr val="D7C95D"/>
    <a:srgbClr val="D97AA5"/>
    <a:srgbClr val="00C7FF"/>
    <a:srgbClr val="FF9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67" autoAdjust="0"/>
    <p:restoredTop sz="94660"/>
  </p:normalViewPr>
  <p:slideViewPr>
    <p:cSldViewPr showGuides="1">
      <p:cViewPr varScale="1">
        <p:scale>
          <a:sx n="68" d="100"/>
          <a:sy n="68" d="100"/>
        </p:scale>
        <p:origin x="1614" y="60"/>
      </p:cViewPr>
      <p:guideLst>
        <p:guide orient="horz" pos="2704"/>
        <p:guide orient="horz" pos="1434"/>
        <p:guide pos="884"/>
        <p:guide pos="4513"/>
        <p:guide pos="567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F2DFB-7481-493A-BA16-99A77C399DFF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2EFBB-6D23-43A9-B9D3-B74D6875C8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534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17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70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7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83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31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9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5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5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3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70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44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1119" y="6381328"/>
            <a:ext cx="7852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3 Fig. Distributions of five barcode factors (GCC, HP, SR, HD, and CP) observed in random barcodes with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l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=18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751801" y="26064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09741" y="227687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758213" y="22768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d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03329" y="436510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e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783861" y="4365104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f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03329" y="26064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8064" y="260648"/>
            <a:ext cx="3254400" cy="179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8064" y="2276872"/>
            <a:ext cx="3254400" cy="18044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92" y="4365104"/>
            <a:ext cx="3254400" cy="179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8064" y="4365104"/>
            <a:ext cx="3254400" cy="1797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10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92" y="2276872"/>
            <a:ext cx="3254400" cy="18015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11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92" y="260648"/>
            <a:ext cx="3254400" cy="180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49278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16</TotalTime>
  <Words>35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의생명과학부)</dc:creator>
  <cp:lastModifiedBy>Editor</cp:lastModifiedBy>
  <cp:revision>414</cp:revision>
  <dcterms:created xsi:type="dcterms:W3CDTF">2016-11-08T07:30:46Z</dcterms:created>
  <dcterms:modified xsi:type="dcterms:W3CDTF">2021-02-06T15:38:25Z</dcterms:modified>
</cp:coreProperties>
</file>